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5" r:id="rId2"/>
    <p:sldId id="279" r:id="rId3"/>
    <p:sldId id="287" r:id="rId4"/>
    <p:sldId id="288" r:id="rId5"/>
    <p:sldId id="284" r:id="rId6"/>
    <p:sldId id="286" r:id="rId7"/>
    <p:sldId id="282" r:id="rId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4040FF"/>
    <a:srgbClr val="FFFFFF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3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8" y="53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50" tIns="46576" rIns="93150" bIns="46576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50" tIns="46576" rIns="93150" bIns="46576" rtlCol="0"/>
          <a:lstStyle>
            <a:lvl1pPr algn="r">
              <a:defRPr sz="1200"/>
            </a:lvl1pPr>
          </a:lstStyle>
          <a:p>
            <a:fld id="{90B8DC4F-AC1E-42E2-B64F-2F9BA6FEC024}" type="datetimeFigureOut">
              <a:rPr lang="en-US" smtClean="0"/>
              <a:t>1/8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50" tIns="46576" rIns="93150" bIns="46576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50" tIns="46576" rIns="93150" bIns="4657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50" tIns="46576" rIns="93150" bIns="46576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50" tIns="46576" rIns="93150" bIns="46576" rtlCol="0" anchor="b"/>
          <a:lstStyle>
            <a:lvl1pPr algn="r">
              <a:defRPr sz="1200"/>
            </a:lvl1pPr>
          </a:lstStyle>
          <a:p>
            <a:fld id="{76382E73-9EBC-4016-AF3C-81CD3C7AD1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73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7439D-3C40-4372-99C1-D1389278F327}" type="datetimeFigureOut">
              <a:rPr lang="en-US" smtClean="0"/>
              <a:pPr/>
              <a:t>1/8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6B2B1-7741-4605-AAAC-A53BEC379AF8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2844410" y="289719"/>
            <a:ext cx="865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A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04" y="659051"/>
            <a:ext cx="6624798" cy="24488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41645" y="3738070"/>
            <a:ext cx="8575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B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1471" y="4107402"/>
            <a:ext cx="360159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142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8811" y="1741199"/>
            <a:ext cx="4340377" cy="5661601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3124389" y="1371867"/>
            <a:ext cx="855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</a:t>
            </a:r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051847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098445" y="3967799"/>
            <a:ext cx="844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E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947483" y="205760"/>
            <a:ext cx="875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D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671795" y="6931742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71795" y="3145630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322" y="4337131"/>
            <a:ext cx="6573498" cy="259461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323" y="614271"/>
            <a:ext cx="6573498" cy="2584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8430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61818" y="23215"/>
            <a:ext cx="838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F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661818" y="2637069"/>
            <a:ext cx="878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G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785427" y="5692283"/>
            <a:ext cx="876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H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254544" y="2529385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54546" y="5522620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54545" y="8613896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042" y="381456"/>
            <a:ext cx="6103398" cy="221635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042" y="6057692"/>
            <a:ext cx="6103398" cy="256012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024029"/>
            <a:ext cx="6245440" cy="24985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3231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109" y="1000433"/>
            <a:ext cx="5391150" cy="28956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013674" y="631101"/>
            <a:ext cx="790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</a:t>
            </a:r>
            <a:r>
              <a:rPr lang="en-US" dirty="0"/>
              <a:t>I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109" y="4863895"/>
            <a:ext cx="5353050" cy="28575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900603" y="4494563"/>
            <a:ext cx="806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J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949744" y="3872133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872709" y="7690063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0965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19" y="2891680"/>
            <a:ext cx="6636774" cy="260179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36910" y="2522348"/>
            <a:ext cx="852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K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754539" y="5493472"/>
            <a:ext cx="2103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adout values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m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2702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92" y="3173478"/>
            <a:ext cx="6617110" cy="1899966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016691" y="2804146"/>
            <a:ext cx="929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M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89" y="605541"/>
            <a:ext cx="6587613" cy="1852374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3016691" y="294970"/>
            <a:ext cx="830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882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35</TotalTime>
  <Words>58</Words>
  <Application>Microsoft Office PowerPoint</Application>
  <PresentationFormat>On-screen Show (4:3)</PresentationFormat>
  <Paragraphs>2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iomari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yogalingam</dc:creator>
  <cp:lastModifiedBy>Gouri Yogalingam</cp:lastModifiedBy>
  <cp:revision>591</cp:revision>
  <cp:lastPrinted>2018-12-06T20:37:59Z</cp:lastPrinted>
  <dcterms:created xsi:type="dcterms:W3CDTF">2014-01-15T04:24:36Z</dcterms:created>
  <dcterms:modified xsi:type="dcterms:W3CDTF">2019-01-08T21:14:46Z</dcterms:modified>
</cp:coreProperties>
</file>